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8" r:id="rId2"/>
    <p:sldId id="269" r:id="rId3"/>
    <p:sldId id="270" r:id="rId4"/>
    <p:sldId id="271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86" autoAdjust="0"/>
    <p:restoredTop sz="94660"/>
  </p:normalViewPr>
  <p:slideViewPr>
    <p:cSldViewPr snapToGrid="0">
      <p:cViewPr varScale="1">
        <p:scale>
          <a:sx n="163" d="100"/>
          <a:sy n="163" d="100"/>
        </p:scale>
        <p:origin x="276" y="15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C4F853-3456-4A72-832F-FEF825B7E969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805A84-F2EC-401B-A0C8-E826D33EE30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48024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8406DAC-495D-E222-5C58-1C4ACFA0F7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4EA081F7-84C7-66CD-70C1-E055693BEC8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712FD46B-DFF6-C304-2818-3FE3A96FF33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3E219C4-C454-7DB1-7F1A-1A7722E9FCE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FB4B57-471F-4AD4-BBB5-7415CB28D1FB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371203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6DAD45A-9D87-8D0E-2607-C5FD79E4037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19D32ECB-A577-332D-BEE1-85BBEFEE80F7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65FB7570-1501-FA04-F279-89732778D21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3C11D7D5-7F08-EEDA-EEEF-4032F7097D0A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FB4B57-471F-4AD4-BBB5-7415CB28D1FB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1376613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54E7276-DB3A-C012-A6A7-65528996072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D78ACA7C-B5E1-A7DA-03DF-53D57FD02068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87C7BB0B-AD75-6A15-9882-AEABEF87CA1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4D06805-E137-01A8-4A07-A264121A6DC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FB4B57-471F-4AD4-BBB5-7415CB28D1FB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51029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6798A5F-C385-9EEE-FABE-F988E59DB0B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B43C08A5-C4EB-6186-EFAE-E1D4A835291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670C6E60-C86F-60B7-1374-90972584FCA5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A6D067D-90CA-7FE4-3113-5B69725D02D1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DFB4B57-471F-4AD4-BBB5-7415CB28D1FB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45388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28212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956291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8069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43763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215623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31520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377245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4201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3888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868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950935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E993BD-07D0-429B-873D-A540903E9BFA}" type="datetimeFigureOut">
              <a:rPr lang="de-DE" smtClean="0"/>
              <a:t>27.03.202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082C9-DEE8-4FAF-9208-BF85B8ED834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4240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9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tiff"/><Relationship Id="rId5" Type="http://schemas.openxmlformats.org/officeDocument/2006/relationships/image" Target="../media/image7.tiff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13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7" Type="http://schemas.openxmlformats.org/officeDocument/2006/relationships/image" Target="../media/image17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E07A692-47A2-4FBF-D76A-89508B41306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6FB3274-503C-463A-9C2D-4B8DE3530E6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2440"/>
          <a:stretch/>
        </p:blipFill>
        <p:spPr>
          <a:xfrm>
            <a:off x="266978" y="2050889"/>
            <a:ext cx="2531641" cy="3587496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527BA82D-8778-953A-1B1E-DAE415C96FB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469" y="2053937"/>
            <a:ext cx="2606040" cy="358444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C471E23D-FC59-171B-39D2-9DF24B05A5F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2359" y="2050889"/>
            <a:ext cx="2606040" cy="3584448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62010A19-816C-2CA0-40E0-0A29964F71F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62249" y="2050889"/>
            <a:ext cx="2606040" cy="3584448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29EAD6CD-A72F-0F5F-2AAF-97130125D12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05" t="15050" r="-210" b="70533"/>
          <a:stretch/>
        </p:blipFill>
        <p:spPr>
          <a:xfrm>
            <a:off x="9573310" y="1080654"/>
            <a:ext cx="1834299" cy="517237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62681517-60B6-377A-8539-2F8E6CA49A71}"/>
              </a:ext>
            </a:extLst>
          </p:cNvPr>
          <p:cNvSpPr txBox="1"/>
          <p:nvPr/>
        </p:nvSpPr>
        <p:spPr>
          <a:xfrm>
            <a:off x="480291" y="895988"/>
            <a:ext cx="2478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黑体" panose="02010609060101010101" pitchFamily="49" charset="-122"/>
                <a:cs typeface="Calibri" panose="020F0502020204030204" pitchFamily="34" charset="0"/>
              </a:rPr>
              <a:t>Housekeeping gene: 18S</a:t>
            </a:r>
            <a:endParaRPr lang="zh-CN" altLang="en-US" dirty="0">
              <a:latin typeface="Calibri" panose="020F0502020204030204" pitchFamily="34" charset="0"/>
              <a:ea typeface="黑体" panose="02010609060101010101" pitchFamily="49" charset="-122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312901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CEF03C8-D3ED-779B-8054-B842F32C1F8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17A76126-BE89-BD68-0840-1B25DE4C813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05" t="15050" r="-210" b="70533"/>
          <a:stretch/>
        </p:blipFill>
        <p:spPr>
          <a:xfrm>
            <a:off x="9573310" y="1080654"/>
            <a:ext cx="1834299" cy="517237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FA262E06-DC72-FD1B-9EFA-83D8FD41ADDE}"/>
              </a:ext>
            </a:extLst>
          </p:cNvPr>
          <p:cNvSpPr txBox="1"/>
          <p:nvPr/>
        </p:nvSpPr>
        <p:spPr>
          <a:xfrm>
            <a:off x="480291" y="895988"/>
            <a:ext cx="2945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黑体" panose="02010609060101010101" pitchFamily="49" charset="-122"/>
                <a:cs typeface="Calibri" panose="020F0502020204030204" pitchFamily="34" charset="0"/>
              </a:rPr>
              <a:t>Housekeeping gene: </a:t>
            </a:r>
            <a:r>
              <a:rPr lang="en-US" altLang="zh-CN" dirty="0" err="1">
                <a:latin typeface="Calibri" panose="020F0502020204030204" pitchFamily="34" charset="0"/>
                <a:ea typeface="黑体" panose="02010609060101010101" pitchFamily="49" charset="-122"/>
                <a:cs typeface="Calibri" panose="020F0502020204030204" pitchFamily="34" charset="0"/>
              </a:rPr>
              <a:t>hGAPDH</a:t>
            </a:r>
            <a:endParaRPr lang="zh-CN" altLang="en-US" dirty="0">
              <a:latin typeface="Calibri" panose="020F0502020204030204" pitchFamily="34" charset="0"/>
              <a:ea typeface="黑体" panose="02010609060101010101" pitchFamily="49" charset="-122"/>
              <a:cs typeface="Calibri" panose="020F050202020403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E153AEC3-C70B-C2C2-FDF9-73FA9A47161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258" y="2092872"/>
            <a:ext cx="2447544" cy="358749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91D4691-7D4F-D630-FF77-61EF52EED6B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5150" y="2092872"/>
            <a:ext cx="2596896" cy="3572256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71D7F03F-524A-807C-812A-E079E58EE5F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42046" y="2079156"/>
            <a:ext cx="2596896" cy="357225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CEE41591-81DC-75CD-490B-1D03ED9614E4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0290" y="2066964"/>
            <a:ext cx="2606040" cy="3584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74521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1D1CC16-DC7F-092C-DF9A-1096B99111E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65D5CC19-093D-5F94-E06F-CEFC740404A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05" t="15050" r="-210" b="70533"/>
          <a:stretch/>
        </p:blipFill>
        <p:spPr>
          <a:xfrm>
            <a:off x="9573310" y="1080654"/>
            <a:ext cx="1834299" cy="517237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6D488C66-0AB1-1C19-5926-C036BF9543D0}"/>
              </a:ext>
            </a:extLst>
          </p:cNvPr>
          <p:cNvSpPr txBox="1"/>
          <p:nvPr/>
        </p:nvSpPr>
        <p:spPr>
          <a:xfrm>
            <a:off x="480291" y="895988"/>
            <a:ext cx="2954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黑体" panose="02010609060101010101" pitchFamily="49" charset="-122"/>
                <a:cs typeface="Calibri" panose="020F0502020204030204" pitchFamily="34" charset="0"/>
              </a:rPr>
              <a:t>Housekeeping gene: </a:t>
            </a:r>
            <a:r>
              <a:rPr lang="en-US" altLang="zh-CN" dirty="0" err="1">
                <a:latin typeface="Calibri" panose="020F0502020204030204" pitchFamily="34" charset="0"/>
                <a:ea typeface="黑体" panose="02010609060101010101" pitchFamily="49" charset="-122"/>
                <a:cs typeface="Calibri" panose="020F0502020204030204" pitchFamily="34" charset="0"/>
              </a:rPr>
              <a:t>huHMBS</a:t>
            </a:r>
            <a:endParaRPr lang="zh-CN" altLang="en-US" dirty="0">
              <a:latin typeface="Calibri" panose="020F0502020204030204" pitchFamily="34" charset="0"/>
              <a:ea typeface="黑体" panose="02010609060101010101" pitchFamily="49" charset="-122"/>
              <a:cs typeface="Calibri" panose="020F050202020403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880BB0A4-5308-B5D2-B818-EA39AC7CB634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601" y="1936776"/>
            <a:ext cx="2606040" cy="358444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FA6227BB-5498-F082-6C26-D3C43F2C8A2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57227" y="1936776"/>
            <a:ext cx="2606040" cy="3584448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AC1F35C-8795-8524-A1C6-20B4FEBFCCE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3267" y="1936776"/>
            <a:ext cx="2606040" cy="3584448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3DD885FF-5D49-916F-971D-243B14B80EB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0290" y="1936776"/>
            <a:ext cx="2606040" cy="3584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49029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8752C9-BD26-D54F-4256-5C57858D4C3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3F69DBBD-3F3E-5AAC-17CB-5D7EA07705E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05" t="15050" r="-210" b="70533"/>
          <a:stretch/>
        </p:blipFill>
        <p:spPr>
          <a:xfrm>
            <a:off x="9573310" y="1080654"/>
            <a:ext cx="1834299" cy="517237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5C3C6B0B-B106-A14D-37FA-3A870FBA4877}"/>
              </a:ext>
            </a:extLst>
          </p:cNvPr>
          <p:cNvSpPr txBox="1"/>
          <p:nvPr/>
        </p:nvSpPr>
        <p:spPr>
          <a:xfrm>
            <a:off x="480291" y="895988"/>
            <a:ext cx="299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Calibri" panose="020F0502020204030204" pitchFamily="34" charset="0"/>
                <a:ea typeface="黑体" panose="02010609060101010101" pitchFamily="49" charset="-122"/>
                <a:cs typeface="Calibri" panose="020F0502020204030204" pitchFamily="34" charset="0"/>
              </a:rPr>
              <a:t>Housekeeping gene: huHPRT1</a:t>
            </a:r>
            <a:endParaRPr lang="zh-CN" altLang="en-US" dirty="0">
              <a:latin typeface="Calibri" panose="020F0502020204030204" pitchFamily="34" charset="0"/>
              <a:ea typeface="黑体" panose="02010609060101010101" pitchFamily="49" charset="-122"/>
              <a:cs typeface="Calibri" panose="020F050202020403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5FE07AC9-281B-3378-1601-0BD84B66C44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046" y="1936776"/>
            <a:ext cx="2447544" cy="3587496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93EDD43-B185-3AD2-685F-A5888712E03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17832" y="1946012"/>
            <a:ext cx="2606040" cy="358444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7A2AB4CD-22AF-B462-E246-99F6D44C87C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5110" y="1946012"/>
            <a:ext cx="2606040" cy="358444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FC3C509-FDCB-8EE5-7039-D04EE37D4BAF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0290" y="1936776"/>
            <a:ext cx="2606040" cy="35844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4312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Breitbild</PresentationFormat>
  <Paragraphs>8</Paragraphs>
  <Slides>4</Slides>
  <Notes>4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等线</vt:lpstr>
      <vt:lpstr>黑体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DKFZ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Novak Daniel</dc:creator>
  <cp:lastModifiedBy>Novak Daniel</cp:lastModifiedBy>
  <cp:revision>63</cp:revision>
  <dcterms:created xsi:type="dcterms:W3CDTF">2023-11-22T15:49:46Z</dcterms:created>
  <dcterms:modified xsi:type="dcterms:W3CDTF">2025-03-27T09:58:59Z</dcterms:modified>
</cp:coreProperties>
</file>